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77" r:id="rId2"/>
    <p:sldId id="261" r:id="rId3"/>
    <p:sldId id="272" r:id="rId4"/>
    <p:sldId id="271" r:id="rId5"/>
    <p:sldId id="273" r:id="rId6"/>
    <p:sldId id="262" r:id="rId7"/>
    <p:sldId id="274" r:id="rId8"/>
    <p:sldId id="269" r:id="rId9"/>
    <p:sldId id="275" r:id="rId10"/>
    <p:sldId id="270" r:id="rId11"/>
    <p:sldId id="276" r:id="rId1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088" autoAdjust="0"/>
  </p:normalViewPr>
  <p:slideViewPr>
    <p:cSldViewPr snapToGrid="0">
      <p:cViewPr varScale="1">
        <p:scale>
          <a:sx n="56" d="100"/>
          <a:sy n="56" d="100"/>
        </p:scale>
        <p:origin x="265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6664D8-2384-418E-9629-4F772264E91F}" type="datetimeFigureOut">
              <a:rPr lang="en-AU" smtClean="0"/>
              <a:t>13/08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38C407-6035-4001-A804-C10F2911445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25247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38C407-6035-4001-A804-C10F2911445E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97109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38C407-6035-4001-A804-C10F2911445E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70459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73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512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801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235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830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685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395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856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311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065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676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702A5-0421-4816-B5E3-DA4068AECF51}" type="datetimeFigureOut">
              <a:rPr lang="en-US" smtClean="0"/>
              <a:t>8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CC746-EE3B-41AB-8451-5EADC4BC1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44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tiff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10" Type="http://schemas.openxmlformats.org/officeDocument/2006/relationships/oleObject" Target="../embeddings/oleObject4.bin"/><Relationship Id="rId4" Type="http://schemas.openxmlformats.org/officeDocument/2006/relationships/image" Target="../media/image1.emf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oleObject" Target="../embeddings/oleObject5.bin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6.bin"/><Relationship Id="rId10" Type="http://schemas.openxmlformats.org/officeDocument/2006/relationships/image" Target="../media/image11.png"/><Relationship Id="rId4" Type="http://schemas.openxmlformats.org/officeDocument/2006/relationships/image" Target="../media/image7.emf"/><Relationship Id="rId9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emf"/><Relationship Id="rId4" Type="http://schemas.openxmlformats.org/officeDocument/2006/relationships/oleObject" Target="../embeddings/oleObject7.bin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emf"/><Relationship Id="rId4" Type="http://schemas.openxmlformats.org/officeDocument/2006/relationships/oleObject" Target="../embeddings/oleObject9.bin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A62B7EA-1C57-4CBE-9321-AD1FD9D7B8B1}"/>
              </a:ext>
            </a:extLst>
          </p:cNvPr>
          <p:cNvSpPr txBox="1"/>
          <p:nvPr/>
        </p:nvSpPr>
        <p:spPr>
          <a:xfrm>
            <a:off x="518614" y="618715"/>
            <a:ext cx="5996485" cy="7011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s for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of CD49f defines subsets of human regulatory T cells with divergent transcriptional landscape and function that correlate with ulcerative colitis disease activity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rshi Weerakoon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2,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Jasmin Straube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Katie Lineburg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eanne Coop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teven Lane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,7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orey Smith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Saleh Alabbas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akob Begun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,7,8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John J Miles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,1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ichelle M Hill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1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#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Ailin Lepletier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9,12,13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#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Comparative proteomic analysis of circulating regulatory T cells and conventional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.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Regulatory T cell-mediated suppression and pro- inflammatory cytokines production.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 Genes modulated in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ersus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gulatory T cells.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 Modulation of immune markers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in subsets of regulatory T cells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Correlation of CD49f expression on Treg with disease activity in patients with UC.</a:t>
            </a:r>
          </a:p>
          <a:p>
            <a:b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</a:b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72477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46F80319-9A94-4371-AA9D-0D203A56474B}"/>
              </a:ext>
            </a:extLst>
          </p:cNvPr>
          <p:cNvGrpSpPr/>
          <p:nvPr/>
        </p:nvGrpSpPr>
        <p:grpSpPr>
          <a:xfrm>
            <a:off x="207086" y="309606"/>
            <a:ext cx="5507914" cy="8353382"/>
            <a:chOff x="207086" y="309606"/>
            <a:chExt cx="5507914" cy="835338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5F9C225-6627-4FA9-BA26-A4DBF91E6173}"/>
                </a:ext>
              </a:extLst>
            </p:cNvPr>
            <p:cNvSpPr txBox="1"/>
            <p:nvPr/>
          </p:nvSpPr>
          <p:spPr>
            <a:xfrm>
              <a:off x="207086" y="309606"/>
              <a:ext cx="33698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5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BA1FAA3-DA41-4116-9836-5AD0C3E3780C}"/>
                </a:ext>
              </a:extLst>
            </p:cNvPr>
            <p:cNvGrpSpPr/>
            <p:nvPr/>
          </p:nvGrpSpPr>
          <p:grpSpPr>
            <a:xfrm>
              <a:off x="760413" y="995363"/>
              <a:ext cx="4954587" cy="7667625"/>
              <a:chOff x="671513" y="1350963"/>
              <a:chExt cx="4954587" cy="7667625"/>
            </a:xfrm>
          </p:grpSpPr>
          <p:graphicFrame>
            <p:nvGraphicFramePr>
              <p:cNvPr id="10" name="Object 9">
                <a:extLst>
                  <a:ext uri="{FF2B5EF4-FFF2-40B4-BE49-F238E27FC236}">
                    <a16:creationId xmlns:a16="http://schemas.microsoft.com/office/drawing/2014/main" id="{7A9CDCD7-F4C0-4A61-94D5-5C34C00DBAE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57007047"/>
                  </p:ext>
                </p:extLst>
              </p:nvPr>
            </p:nvGraphicFramePr>
            <p:xfrm>
              <a:off x="671513" y="1350963"/>
              <a:ext cx="4954587" cy="76676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3593064" imgH="5549888" progId="Prism8.Document">
                      <p:embed/>
                    </p:oleObj>
                  </mc:Choice>
                  <mc:Fallback>
                    <p:oleObj name="Prism 8" r:id="rId2" imgW="3593064" imgH="5549888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671513" y="1350963"/>
                            <a:ext cx="4954587" cy="76676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2C149BF3-0F87-472F-AFB7-3BB597E39D53}"/>
                  </a:ext>
                </a:extLst>
              </p:cNvPr>
              <p:cNvSpPr txBox="1"/>
              <p:nvPr/>
            </p:nvSpPr>
            <p:spPr>
              <a:xfrm>
                <a:off x="691404" y="1357299"/>
                <a:ext cx="40267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E2286B2-B782-4AC9-B966-7687A4BF0F71}"/>
                  </a:ext>
                </a:extLst>
              </p:cNvPr>
              <p:cNvSpPr txBox="1"/>
              <p:nvPr/>
            </p:nvSpPr>
            <p:spPr>
              <a:xfrm>
                <a:off x="3150939" y="1353834"/>
                <a:ext cx="6088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753BC98-32B3-48B0-A5F2-4A2D8CB8A0E4}"/>
                  </a:ext>
                </a:extLst>
              </p:cNvPr>
              <p:cNvSpPr txBox="1"/>
              <p:nvPr/>
            </p:nvSpPr>
            <p:spPr>
              <a:xfrm>
                <a:off x="691403" y="3800414"/>
                <a:ext cx="4667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2A28592-26D9-4D7C-85B3-B1733605A780}"/>
                  </a:ext>
                </a:extLst>
              </p:cNvPr>
              <p:cNvSpPr txBox="1"/>
              <p:nvPr/>
            </p:nvSpPr>
            <p:spPr>
              <a:xfrm>
                <a:off x="3150940" y="3798576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d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CF69405-DFCA-4575-AFCB-15632E11EE28}"/>
                  </a:ext>
                </a:extLst>
              </p:cNvPr>
              <p:cNvSpPr txBox="1"/>
              <p:nvPr/>
            </p:nvSpPr>
            <p:spPr>
              <a:xfrm>
                <a:off x="691404" y="6208334"/>
                <a:ext cx="46679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e)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6795D9B-5C6E-4C68-B649-3D55B9718D66}"/>
                </a:ext>
              </a:extLst>
            </p:cNvPr>
            <p:cNvSpPr txBox="1"/>
            <p:nvPr/>
          </p:nvSpPr>
          <p:spPr>
            <a:xfrm>
              <a:off x="3249184" y="5852734"/>
              <a:ext cx="4667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75621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4E568D-7AED-41F2-8010-72A51D69669C}"/>
              </a:ext>
            </a:extLst>
          </p:cNvPr>
          <p:cNvSpPr txBox="1"/>
          <p:nvPr/>
        </p:nvSpPr>
        <p:spPr>
          <a:xfrm>
            <a:off x="495300" y="501708"/>
            <a:ext cx="5867400" cy="70318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5. Correlation of CD49f expression on Treg with disease activity in patients with UC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equencies of Treg in PBMC from patients with active UC (n = 10), non-active UC (n = 13) and healthy controls (HC, n = 10)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Proportion of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 in total T cells. n.s. = non-significant, P*&lt;0.05. Non-parametric one-way ANOVA test with Bonferroni correction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Proportion of Treg cells in total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. n.s. = non-significant. Non-parametric one-way ANOVA test with Bonferroni correction. 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Proportion of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in resting Treg. n.s. = non-significant. P*&lt;0.05. Non-parametric one-way ANOVA test with Bonferroni correction. </a:t>
            </a:r>
          </a:p>
          <a:p>
            <a:pPr marL="228600" indent="-228600" algn="just">
              <a:lnSpc>
                <a:spcPct val="200000"/>
              </a:lnSpc>
              <a:spcAft>
                <a:spcPts val="800"/>
              </a:spcAft>
              <a:buAutoNum type="alphaLcParenBoth" startAt="4"/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portion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in resting Treg. n.s. = non-significant. Non-parametric one-way ANOVA test with Bonferroni correction. 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Resting Treg CD49f index, representing the ratio of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ver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sting Treg. n.s. = non-significant. Non-parametric one-way ANOVA test with Bonferroni correction. 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portion of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in FoxP3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on-Treg. n.s. = non-significant. Non-parametric one-way ANOVA test with Bonferroni correction. </a:t>
            </a:r>
          </a:p>
        </p:txBody>
      </p:sp>
    </p:spTree>
    <p:extLst>
      <p:ext uri="{BB962C8B-B14F-4D97-AF65-F5344CB8AC3E}">
        <p14:creationId xmlns:p14="http://schemas.microsoft.com/office/powerpoint/2010/main" val="2475635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C92ABDC8-B8F9-43CC-AF43-CA252FCA9085}"/>
              </a:ext>
            </a:extLst>
          </p:cNvPr>
          <p:cNvGrpSpPr/>
          <p:nvPr/>
        </p:nvGrpSpPr>
        <p:grpSpPr>
          <a:xfrm>
            <a:off x="819793" y="1170642"/>
            <a:ext cx="5632382" cy="7082355"/>
            <a:chOff x="819793" y="1143346"/>
            <a:chExt cx="5632382" cy="7082355"/>
          </a:xfrm>
        </p:grpSpPr>
        <p:graphicFrame>
          <p:nvGraphicFramePr>
            <p:cNvPr id="31" name="Object 30">
              <a:extLst>
                <a:ext uri="{FF2B5EF4-FFF2-40B4-BE49-F238E27FC236}">
                  <a16:creationId xmlns:a16="http://schemas.microsoft.com/office/drawing/2014/main" id="{F254E5C8-BE71-4D29-B81F-4402D11EE80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07161498"/>
                </p:ext>
              </p:extLst>
            </p:nvPr>
          </p:nvGraphicFramePr>
          <p:xfrm>
            <a:off x="3195638" y="3097213"/>
            <a:ext cx="2761139" cy="226943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3480398" imgH="2858815" progId="Prism8.Document">
                    <p:embed/>
                  </p:oleObj>
                </mc:Choice>
                <mc:Fallback>
                  <p:oleObj name="Prism 8" r:id="rId3" imgW="3480398" imgH="2858815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95638" y="3097213"/>
                          <a:ext cx="2761139" cy="226943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F154806-A89D-4084-AE24-DEEF0F81CC22}"/>
                </a:ext>
              </a:extLst>
            </p:cNvPr>
            <p:cNvSpPr txBox="1"/>
            <p:nvPr/>
          </p:nvSpPr>
          <p:spPr>
            <a:xfrm>
              <a:off x="1590893" y="7705503"/>
              <a:ext cx="5057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reg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Left Brace 37">
              <a:extLst>
                <a:ext uri="{FF2B5EF4-FFF2-40B4-BE49-F238E27FC236}">
                  <a16:creationId xmlns:a16="http://schemas.microsoft.com/office/drawing/2014/main" id="{90D1DBB2-C725-4F7D-B958-B491BD447C93}"/>
                </a:ext>
              </a:extLst>
            </p:cNvPr>
            <p:cNvSpPr/>
            <p:nvPr/>
          </p:nvSpPr>
          <p:spPr>
            <a:xfrm rot="16200000">
              <a:off x="1813680" y="7364630"/>
              <a:ext cx="45719" cy="63862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44522A53-5B53-4E11-BFCB-0A77F30CBE7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8233966"/>
                </p:ext>
              </p:extLst>
            </p:nvPr>
          </p:nvGraphicFramePr>
          <p:xfrm>
            <a:off x="879475" y="1338263"/>
            <a:ext cx="2222500" cy="19986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2831400" imgH="2544929" progId="Prism8.Document">
                    <p:embed/>
                  </p:oleObj>
                </mc:Choice>
                <mc:Fallback>
                  <p:oleObj name="Prism 8" r:id="rId5" imgW="2831400" imgH="2544929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6">
                          <a:lum bright="1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879475" y="1338263"/>
                          <a:ext cx="2222500" cy="19986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59E41E48-A467-4DEF-8D49-D1EC8BAD4A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7743"/>
            <a:stretch/>
          </p:blipFill>
          <p:spPr>
            <a:xfrm>
              <a:off x="1173458" y="5570333"/>
              <a:ext cx="1996092" cy="2038975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19C0F7B-CEFA-45AE-8458-9B8A8066A080}"/>
                </a:ext>
              </a:extLst>
            </p:cNvPr>
            <p:cNvSpPr txBox="1"/>
            <p:nvPr/>
          </p:nvSpPr>
          <p:spPr>
            <a:xfrm>
              <a:off x="2181192" y="7714188"/>
              <a:ext cx="959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v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D4</a:t>
              </a:r>
              <a:r>
                <a: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6" name="Left Brace 35">
              <a:extLst>
                <a:ext uri="{FF2B5EF4-FFF2-40B4-BE49-F238E27FC236}">
                  <a16:creationId xmlns:a16="http://schemas.microsoft.com/office/drawing/2014/main" id="{ACFC99A1-8C2A-42C8-9A68-E39DB78F6AC9}"/>
                </a:ext>
              </a:extLst>
            </p:cNvPr>
            <p:cNvSpPr/>
            <p:nvPr/>
          </p:nvSpPr>
          <p:spPr>
            <a:xfrm rot="16200000">
              <a:off x="2595265" y="7362097"/>
              <a:ext cx="65560" cy="638622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351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4D0D639-231E-4F60-8B9A-F75ADE07A0AF}"/>
                </a:ext>
              </a:extLst>
            </p:cNvPr>
            <p:cNvSpPr txBox="1"/>
            <p:nvPr/>
          </p:nvSpPr>
          <p:spPr>
            <a:xfrm>
              <a:off x="854997" y="5518559"/>
              <a:ext cx="4026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9C05243-022B-4DD5-A7FF-99B30DCEE999}"/>
                </a:ext>
              </a:extLst>
            </p:cNvPr>
            <p:cNvSpPr txBox="1"/>
            <p:nvPr/>
          </p:nvSpPr>
          <p:spPr>
            <a:xfrm>
              <a:off x="3439886" y="5500914"/>
              <a:ext cx="51053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D47463A-EF0E-4F48-8ABF-13E25C3DEE6B}"/>
                </a:ext>
              </a:extLst>
            </p:cNvPr>
            <p:cNvSpPr txBox="1"/>
            <p:nvPr/>
          </p:nvSpPr>
          <p:spPr>
            <a:xfrm>
              <a:off x="872132" y="3070839"/>
              <a:ext cx="46679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DE242737-FED1-43D7-A7D3-D68715BD9B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5334150"/>
                </p:ext>
              </p:extLst>
            </p:nvPr>
          </p:nvGraphicFramePr>
          <p:xfrm>
            <a:off x="892000" y="3281174"/>
            <a:ext cx="2362614" cy="23015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009578" imgH="2931887" progId="Prism8.Document">
                    <p:embed/>
                  </p:oleObj>
                </mc:Choice>
                <mc:Fallback>
                  <p:oleObj name="Prism 8" r:id="rId8" imgW="3009578" imgH="2931887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892000" y="3281174"/>
                          <a:ext cx="2362614" cy="23015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6D54A827-1211-4673-922D-A5E73FAEAC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37229029"/>
                </p:ext>
              </p:extLst>
            </p:nvPr>
          </p:nvGraphicFramePr>
          <p:xfrm>
            <a:off x="3499225" y="5908325"/>
            <a:ext cx="1799081" cy="23173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291829" imgH="2953125" progId="Prism8.Document">
                    <p:embed/>
                  </p:oleObj>
                </mc:Choice>
                <mc:Fallback>
                  <p:oleObj name="Prism 8" r:id="rId10" imgW="2291829" imgH="2953125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3499225" y="5908325"/>
                          <a:ext cx="1799081" cy="231737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574E6AC-D5F8-4EB8-ABE6-84EAA1C0EA94}"/>
                </a:ext>
              </a:extLst>
            </p:cNvPr>
            <p:cNvSpPr txBox="1"/>
            <p:nvPr/>
          </p:nvSpPr>
          <p:spPr>
            <a:xfrm>
              <a:off x="3240871" y="3078861"/>
              <a:ext cx="512263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8000D0A7-0B6F-41A5-B076-DA93E1F6B01E}"/>
                </a:ext>
              </a:extLst>
            </p:cNvPr>
            <p:cNvGrpSpPr/>
            <p:nvPr/>
          </p:nvGrpSpPr>
          <p:grpSpPr>
            <a:xfrm>
              <a:off x="3241319" y="1400542"/>
              <a:ext cx="3210856" cy="1764927"/>
              <a:chOff x="2294261" y="1298942"/>
              <a:chExt cx="3210856" cy="1764927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F91A173D-21AE-4DFA-A88E-9DC292251E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t="-1" r="54881" b="68752"/>
              <a:stretch/>
            </p:blipFill>
            <p:spPr>
              <a:xfrm>
                <a:off x="2294261" y="1298942"/>
                <a:ext cx="2623046" cy="815697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48747A99-4078-48F5-98BD-A5B73B983F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71613" r="-160" b="74154"/>
              <a:stretch/>
            </p:blipFill>
            <p:spPr>
              <a:xfrm>
                <a:off x="3845482" y="2312121"/>
                <a:ext cx="1659635" cy="674686"/>
              </a:xfrm>
              <a:prstGeom prst="rect">
                <a:avLst/>
              </a:prstGeom>
            </p:spPr>
          </p:pic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F344C2F6-0095-4846-ACB2-EBA9676954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48770" t="-1" r="29797" b="68752"/>
              <a:stretch/>
            </p:blipFill>
            <p:spPr>
              <a:xfrm>
                <a:off x="2417296" y="2248172"/>
                <a:ext cx="1246037" cy="815697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95273F46-3391-4347-8F95-3813D8D666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62560" t="-1" r="29797" b="85516"/>
              <a:stretch/>
            </p:blipFill>
            <p:spPr>
              <a:xfrm rot="7479587">
                <a:off x="3092399" y="2000264"/>
                <a:ext cx="420323" cy="362284"/>
              </a:xfrm>
              <a:prstGeom prst="rect">
                <a:avLst/>
              </a:prstGeom>
            </p:spPr>
          </p:pic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E8D75B1C-74DC-4CA9-8AC9-99150D469E8C}"/>
                  </a:ext>
                </a:extLst>
              </p:cNvPr>
              <p:cNvSpPr/>
              <p:nvPr/>
            </p:nvSpPr>
            <p:spPr>
              <a:xfrm>
                <a:off x="4691743" y="1466746"/>
                <a:ext cx="225563" cy="106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1C1BB56-2DF8-4315-9F11-A521092A0AA4}"/>
                </a:ext>
              </a:extLst>
            </p:cNvPr>
            <p:cNvSpPr txBox="1"/>
            <p:nvPr/>
          </p:nvSpPr>
          <p:spPr>
            <a:xfrm>
              <a:off x="3140347" y="1143346"/>
              <a:ext cx="479618" cy="4320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2A2FA21-01AB-43A5-BB46-2AD21C525F4F}"/>
                </a:ext>
              </a:extLst>
            </p:cNvPr>
            <p:cNvSpPr txBox="1"/>
            <p:nvPr/>
          </p:nvSpPr>
          <p:spPr>
            <a:xfrm>
              <a:off x="872075" y="3117139"/>
              <a:ext cx="4026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CB609AB-3211-45C3-A359-B929CDFD5D9F}"/>
                </a:ext>
              </a:extLst>
            </p:cNvPr>
            <p:cNvSpPr txBox="1"/>
            <p:nvPr/>
          </p:nvSpPr>
          <p:spPr>
            <a:xfrm>
              <a:off x="819793" y="1143346"/>
              <a:ext cx="4578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8669B0B-F427-4DA9-B8E0-D44F5588C1F7}"/>
                </a:ext>
              </a:extLst>
            </p:cNvPr>
            <p:cNvSpPr txBox="1"/>
            <p:nvPr/>
          </p:nvSpPr>
          <p:spPr>
            <a:xfrm>
              <a:off x="3240814" y="3127853"/>
              <a:ext cx="51226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A698AD6-F3F3-4772-AA69-F6373F769EFF}"/>
                </a:ext>
              </a:extLst>
            </p:cNvPr>
            <p:cNvSpPr txBox="1"/>
            <p:nvPr/>
          </p:nvSpPr>
          <p:spPr>
            <a:xfrm>
              <a:off x="3140290" y="1146038"/>
              <a:ext cx="47961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D4B8886D-AD0D-4AB6-B5B0-1251B3EBBA3E}"/>
              </a:ext>
            </a:extLst>
          </p:cNvPr>
          <p:cNvSpPr txBox="1"/>
          <p:nvPr/>
        </p:nvSpPr>
        <p:spPr>
          <a:xfrm>
            <a:off x="207086" y="309606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811837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FD9C2EB-1903-4CFD-873B-23478E4A7F32}"/>
              </a:ext>
            </a:extLst>
          </p:cNvPr>
          <p:cNvSpPr txBox="1"/>
          <p:nvPr/>
        </p:nvSpPr>
        <p:spPr>
          <a:xfrm>
            <a:off x="495300" y="459817"/>
            <a:ext cx="5867400" cy="77705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Comparative proteomic analysis of circulating regulatory T cells and conventional CD4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g (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2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127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 cells (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2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isolated from fresh PBMC of healthy donors for proteomic analysis.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Percentage of missing maxLFQ protein intensity values in three donors analyzed.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Data mining steps used in selection of constantly identified high confident proteins for DE analysis between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reg cells in three donors analyzed. 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Number of proteins quantified at different unique and razor peptide numbers. 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) Protein intensity distribution patterns in three donors analyzed. Box plots comprise of central lines and boxes representing mean values and 95% confidence intervals, respectively. Whiskers representing 2.5 to 97.5 percentiles.</a:t>
            </a:r>
            <a:endParaRPr lang="en-AU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Heatmap analysis of differentially expressed proteins from comparing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g and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. Each column represents individual donors across proteins differentially expressed between Treg versus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n=3; FDR &lt; 0.01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AU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) Box plots displaying the covariance (CV%) of intensities between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reg cells. Boxplots comprise of central lines and boxes representing mean values and 95% confidence intervals, respectively. Whiskers are 2.5 to 97.5 percentiles. </a:t>
            </a:r>
            <a:endParaRPr lang="en-AU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7833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8F5360A-42F0-457D-A3AE-8F1790E977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1598873"/>
              </p:ext>
            </p:extLst>
          </p:nvPr>
        </p:nvGraphicFramePr>
        <p:xfrm>
          <a:off x="920750" y="7011988"/>
          <a:ext cx="2638425" cy="2408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637745" imgH="2407783" progId="Prism8.Document">
                  <p:embed/>
                </p:oleObj>
              </mc:Choice>
              <mc:Fallback>
                <p:oleObj name="Prism 8" r:id="rId3" imgW="2637745" imgH="240778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20750" y="7011988"/>
                        <a:ext cx="2638425" cy="2408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52A1CD8-A73F-4BAD-8D0F-0C2B6B8E0D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8805347"/>
              </p:ext>
            </p:extLst>
          </p:nvPr>
        </p:nvGraphicFramePr>
        <p:xfrm>
          <a:off x="915283" y="4602971"/>
          <a:ext cx="2767066" cy="23203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3292862" imgH="2770265" progId="Prism8.Document">
                  <p:embed/>
                </p:oleObj>
              </mc:Choice>
              <mc:Fallback>
                <p:oleObj name="Prism 8" r:id="rId5" imgW="3292862" imgH="277026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15283" y="4602971"/>
                        <a:ext cx="2767066" cy="23203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73666A2F-889C-493E-A4D1-3B3B120CFA62}"/>
              </a:ext>
            </a:extLst>
          </p:cNvPr>
          <p:cNvSpPr txBox="1"/>
          <p:nvPr/>
        </p:nvSpPr>
        <p:spPr>
          <a:xfrm>
            <a:off x="734717" y="442545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8E70106-EB80-4700-969F-042984007E85}"/>
              </a:ext>
            </a:extLst>
          </p:cNvPr>
          <p:cNvSpPr txBox="1"/>
          <p:nvPr/>
        </p:nvSpPr>
        <p:spPr>
          <a:xfrm>
            <a:off x="3486518" y="4431515"/>
            <a:ext cx="4809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03C321-D53B-44DF-B987-AA06116EADE6}"/>
              </a:ext>
            </a:extLst>
          </p:cNvPr>
          <p:cNvSpPr txBox="1"/>
          <p:nvPr/>
        </p:nvSpPr>
        <p:spPr>
          <a:xfrm>
            <a:off x="734717" y="6802134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6EB8005-CC07-469F-B158-DDBB138C56A3}"/>
              </a:ext>
            </a:extLst>
          </p:cNvPr>
          <p:cNvSpPr txBox="1"/>
          <p:nvPr/>
        </p:nvSpPr>
        <p:spPr>
          <a:xfrm>
            <a:off x="3500166" y="6790655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7F56A227-C8E1-4768-8F4B-16FFB3506FFF}"/>
              </a:ext>
            </a:extLst>
          </p:cNvPr>
          <p:cNvGrpSpPr/>
          <p:nvPr/>
        </p:nvGrpSpPr>
        <p:grpSpPr>
          <a:xfrm>
            <a:off x="3812687" y="6975514"/>
            <a:ext cx="2197922" cy="2211496"/>
            <a:chOff x="3703970" y="4890866"/>
            <a:chExt cx="2298749" cy="2289451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AFA720B3-C7E8-456C-8046-5572833BEB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19000"/>
                      </a14:imgEffect>
                    </a14:imgLayer>
                  </a14:imgProps>
                </a:ext>
              </a:extLst>
            </a:blip>
            <a:srcRect l="7213" b="9548"/>
            <a:stretch/>
          </p:blipFill>
          <p:spPr>
            <a:xfrm>
              <a:off x="3803052" y="4890866"/>
              <a:ext cx="2199667" cy="2111256"/>
            </a:xfrm>
            <a:prstGeom prst="rect">
              <a:avLst/>
            </a:prstGeom>
          </p:spPr>
        </p:pic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932F31EF-56D2-4C43-A842-081167734618}"/>
                </a:ext>
              </a:extLst>
            </p:cNvPr>
            <p:cNvGrpSpPr/>
            <p:nvPr/>
          </p:nvGrpSpPr>
          <p:grpSpPr>
            <a:xfrm>
              <a:off x="3803054" y="6091772"/>
              <a:ext cx="958852" cy="975785"/>
              <a:chOff x="520704" y="2497674"/>
              <a:chExt cx="958852" cy="975785"/>
            </a:xfrm>
          </p:grpSpPr>
          <p:cxnSp>
            <p:nvCxnSpPr>
              <p:cNvPr id="34" name="Straight Arrow Connector 33">
                <a:extLst>
                  <a:ext uri="{FF2B5EF4-FFF2-40B4-BE49-F238E27FC236}">
                    <a16:creationId xmlns:a16="http://schemas.microsoft.com/office/drawing/2014/main" id="{BBEA1677-5576-4BBE-A957-BDB2CC443674}"/>
                  </a:ext>
                </a:extLst>
              </p:cNvPr>
              <p:cNvCxnSpPr/>
              <p:nvPr/>
            </p:nvCxnSpPr>
            <p:spPr>
              <a:xfrm flipV="1">
                <a:off x="520704" y="2497674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>
                <a:extLst>
                  <a:ext uri="{FF2B5EF4-FFF2-40B4-BE49-F238E27FC236}">
                    <a16:creationId xmlns:a16="http://schemas.microsoft.com/office/drawing/2014/main" id="{10E09D97-DD6F-44EF-9A4D-0B2DE247A96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1003306" y="2997209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1FEDDE2-1359-447B-9806-D117E70E450E}"/>
                </a:ext>
              </a:extLst>
            </p:cNvPr>
            <p:cNvSpPr txBox="1"/>
            <p:nvPr/>
          </p:nvSpPr>
          <p:spPr>
            <a:xfrm rot="16200000" flipH="1">
              <a:off x="3258745" y="5395283"/>
              <a:ext cx="1141716" cy="251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FNˠ</a:t>
              </a:r>
              <a:endParaRPr lang="en-AU" sz="11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656348E-78A2-4068-8A4D-204A811498C5}"/>
                </a:ext>
              </a:extLst>
            </p:cNvPr>
            <p:cNvSpPr txBox="1"/>
            <p:nvPr/>
          </p:nvSpPr>
          <p:spPr>
            <a:xfrm flipH="1">
              <a:off x="4718223" y="6929055"/>
              <a:ext cx="1141716" cy="2512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L17A</a:t>
              </a:r>
              <a:endParaRPr lang="en-AU" sz="11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D9E1D16D-F70A-4794-A9C9-04C09B75A9F5}"/>
                </a:ext>
              </a:extLst>
            </p:cNvPr>
            <p:cNvGrpSpPr/>
            <p:nvPr/>
          </p:nvGrpSpPr>
          <p:grpSpPr>
            <a:xfrm>
              <a:off x="3803055" y="6091773"/>
              <a:ext cx="958852" cy="975785"/>
              <a:chOff x="520704" y="2497674"/>
              <a:chExt cx="958852" cy="975785"/>
            </a:xfrm>
          </p:grpSpPr>
          <p:cxnSp>
            <p:nvCxnSpPr>
              <p:cNvPr id="23" name="Straight Arrow Connector 22">
                <a:extLst>
                  <a:ext uri="{FF2B5EF4-FFF2-40B4-BE49-F238E27FC236}">
                    <a16:creationId xmlns:a16="http://schemas.microsoft.com/office/drawing/2014/main" id="{7F47EB6E-FB17-40AC-9B9B-01161FA10234}"/>
                  </a:ext>
                </a:extLst>
              </p:cNvPr>
              <p:cNvCxnSpPr/>
              <p:nvPr/>
            </p:nvCxnSpPr>
            <p:spPr>
              <a:xfrm flipV="1">
                <a:off x="520704" y="2497674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>
                <a:extLst>
                  <a:ext uri="{FF2B5EF4-FFF2-40B4-BE49-F238E27FC236}">
                    <a16:creationId xmlns:a16="http://schemas.microsoft.com/office/drawing/2014/main" id="{3737C6A1-F2B9-48E5-93F5-224D367FE71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1003306" y="2997209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87307C7-1171-4B66-8C5D-A3677D61B084}"/>
                </a:ext>
              </a:extLst>
            </p:cNvPr>
            <p:cNvSpPr txBox="1"/>
            <p:nvPr/>
          </p:nvSpPr>
          <p:spPr>
            <a:xfrm>
              <a:off x="4124683" y="5021774"/>
              <a:ext cx="489469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050" b="1" dirty="0"/>
                <a:t>4.5%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8ECB91F-BCE0-463F-90B6-2992B45E181D}"/>
                </a:ext>
              </a:extLst>
            </p:cNvPr>
            <p:cNvSpPr txBox="1"/>
            <p:nvPr/>
          </p:nvSpPr>
          <p:spPr>
            <a:xfrm>
              <a:off x="5295071" y="5028702"/>
              <a:ext cx="56477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050" b="1" dirty="0"/>
                <a:t>0.3%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2FA4E61-EEEE-471D-806E-153CD001A671}"/>
                </a:ext>
              </a:extLst>
            </p:cNvPr>
            <p:cNvSpPr txBox="1"/>
            <p:nvPr/>
          </p:nvSpPr>
          <p:spPr>
            <a:xfrm>
              <a:off x="5394691" y="6536462"/>
              <a:ext cx="489469" cy="18634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050" b="1" dirty="0"/>
                <a:t>0.2%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64861A3-B127-4E62-A9E8-D9D4CF4815C3}"/>
                </a:ext>
              </a:extLst>
            </p:cNvPr>
            <p:cNvSpPr/>
            <p:nvPr/>
          </p:nvSpPr>
          <p:spPr>
            <a:xfrm>
              <a:off x="4124683" y="6497782"/>
              <a:ext cx="156366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85EF52CB-0396-4B78-B64C-9026C6E88119}"/>
              </a:ext>
            </a:extLst>
          </p:cNvPr>
          <p:cNvGrpSpPr/>
          <p:nvPr/>
        </p:nvGrpSpPr>
        <p:grpSpPr>
          <a:xfrm>
            <a:off x="3790279" y="4635473"/>
            <a:ext cx="2140171" cy="2231077"/>
            <a:chOff x="3432994" y="1168256"/>
            <a:chExt cx="2431500" cy="250905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0A29FC4-1588-444C-917D-8AE56E8493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9339" b="29751"/>
            <a:stretch/>
          </p:blipFill>
          <p:spPr>
            <a:xfrm>
              <a:off x="3572673" y="1168256"/>
              <a:ext cx="2291821" cy="2240830"/>
            </a:xfrm>
            <a:prstGeom prst="rect">
              <a:avLst/>
            </a:prstGeom>
          </p:spPr>
        </p:pic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5A293A5A-6148-4E13-A698-CA869162D170}"/>
                </a:ext>
              </a:extLst>
            </p:cNvPr>
            <p:cNvGrpSpPr/>
            <p:nvPr/>
          </p:nvGrpSpPr>
          <p:grpSpPr>
            <a:xfrm>
              <a:off x="3548375" y="2643433"/>
              <a:ext cx="868601" cy="880996"/>
              <a:chOff x="520704" y="2497674"/>
              <a:chExt cx="958852" cy="975785"/>
            </a:xfrm>
          </p:grpSpPr>
          <p:cxnSp>
            <p:nvCxnSpPr>
              <p:cNvPr id="31" name="Straight Arrow Connector 30">
                <a:extLst>
                  <a:ext uri="{FF2B5EF4-FFF2-40B4-BE49-F238E27FC236}">
                    <a16:creationId xmlns:a16="http://schemas.microsoft.com/office/drawing/2014/main" id="{C6E48A15-596D-4879-BC72-63F419351B6C}"/>
                  </a:ext>
                </a:extLst>
              </p:cNvPr>
              <p:cNvCxnSpPr/>
              <p:nvPr/>
            </p:nvCxnSpPr>
            <p:spPr>
              <a:xfrm flipV="1">
                <a:off x="520704" y="2497674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A393215F-ED2E-475F-B375-FEA7FD6EFD4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1003306" y="2997209"/>
                <a:ext cx="0" cy="9525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53D018E-9D66-40D0-BD34-5122ABBF7E4D}"/>
                </a:ext>
              </a:extLst>
            </p:cNvPr>
            <p:cNvSpPr txBox="1"/>
            <p:nvPr/>
          </p:nvSpPr>
          <p:spPr>
            <a:xfrm rot="16200000" flipH="1">
              <a:off x="3054063" y="1991558"/>
              <a:ext cx="1030809" cy="272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L17A</a:t>
              </a:r>
              <a:endParaRPr lang="en-AU" sz="11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05079F5-0705-45C4-A5F2-E4276730DC86}"/>
                </a:ext>
              </a:extLst>
            </p:cNvPr>
            <p:cNvSpPr txBox="1"/>
            <p:nvPr/>
          </p:nvSpPr>
          <p:spPr>
            <a:xfrm flipH="1">
              <a:off x="4391011" y="3404362"/>
              <a:ext cx="1034253" cy="272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AU" sz="11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2A14293B-F51C-44E1-A9B1-14E2C8D677B7}"/>
                </a:ext>
              </a:extLst>
            </p:cNvPr>
            <p:cNvSpPr/>
            <p:nvPr/>
          </p:nvSpPr>
          <p:spPr>
            <a:xfrm>
              <a:off x="5363067" y="1764343"/>
              <a:ext cx="386590" cy="1226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AADD99A-DEF6-4178-8476-38252DFFCC67}"/>
                </a:ext>
              </a:extLst>
            </p:cNvPr>
            <p:cNvSpPr txBox="1"/>
            <p:nvPr/>
          </p:nvSpPr>
          <p:spPr>
            <a:xfrm>
              <a:off x="5308518" y="1844296"/>
              <a:ext cx="521563" cy="28555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AU" sz="1050" b="1" dirty="0"/>
                <a:t>0.6%</a:t>
              </a: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965F21E3-E4D0-4CD9-81D0-848B00A6BF74}"/>
              </a:ext>
            </a:extLst>
          </p:cNvPr>
          <p:cNvSpPr txBox="1"/>
          <p:nvPr/>
        </p:nvSpPr>
        <p:spPr>
          <a:xfrm>
            <a:off x="207086" y="309606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5E98937-EAC7-4D81-AE7B-C99F69C5894C}"/>
              </a:ext>
            </a:extLst>
          </p:cNvPr>
          <p:cNvSpPr txBox="1"/>
          <p:nvPr/>
        </p:nvSpPr>
        <p:spPr>
          <a:xfrm>
            <a:off x="747541" y="861840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27E8C7F-0C3A-4056-9486-A95B5DFF8658}"/>
              </a:ext>
            </a:extLst>
          </p:cNvPr>
          <p:cNvSpPr txBox="1"/>
          <p:nvPr/>
        </p:nvSpPr>
        <p:spPr>
          <a:xfrm>
            <a:off x="4203700" y="8622228"/>
            <a:ext cx="432000" cy="180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AU" sz="1050" b="1" dirty="0"/>
              <a:t>95%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73C4780-2D24-4F02-8CB7-A12D65D369D3}"/>
              </a:ext>
            </a:extLst>
          </p:cNvPr>
          <p:cNvGrpSpPr/>
          <p:nvPr/>
        </p:nvGrpSpPr>
        <p:grpSpPr>
          <a:xfrm>
            <a:off x="266669" y="974278"/>
            <a:ext cx="6209628" cy="3621089"/>
            <a:chOff x="266669" y="972356"/>
            <a:chExt cx="6209628" cy="362108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A070C99-A279-4683-85CB-6BF2B325B3C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6669" y="985946"/>
              <a:ext cx="6209628" cy="3607499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46DA35DE-EFAB-4733-B8D0-5674520730A7}"/>
                </a:ext>
              </a:extLst>
            </p:cNvPr>
            <p:cNvSpPr/>
            <p:nvPr/>
          </p:nvSpPr>
          <p:spPr>
            <a:xfrm>
              <a:off x="1526163" y="990155"/>
              <a:ext cx="4484446" cy="1981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1B331EB9-B833-48B9-8CAD-64033C44C475}"/>
                </a:ext>
              </a:extLst>
            </p:cNvPr>
            <p:cNvSpPr/>
            <p:nvPr/>
          </p:nvSpPr>
          <p:spPr>
            <a:xfrm>
              <a:off x="1052745" y="2995220"/>
              <a:ext cx="5070263" cy="1981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EC3B920-460D-4A03-A9E4-ABB443CE1A5A}"/>
                </a:ext>
              </a:extLst>
            </p:cNvPr>
            <p:cNvSpPr txBox="1"/>
            <p:nvPr/>
          </p:nvSpPr>
          <p:spPr>
            <a:xfrm>
              <a:off x="1478624" y="972356"/>
              <a:ext cx="1637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dirty="0">
                  <a:latin typeface="Arial" panose="020B0604020202020204" pitchFamily="34" charset="0"/>
                  <a:cs typeface="Arial" panose="020B0604020202020204" pitchFamily="34" charset="0"/>
                </a:rPr>
                <a:t>MACS sorting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C51FABF3-915F-4685-8575-22DED1FB08D1}"/>
              </a:ext>
            </a:extLst>
          </p:cNvPr>
          <p:cNvSpPr txBox="1"/>
          <p:nvPr/>
        </p:nvSpPr>
        <p:spPr>
          <a:xfrm>
            <a:off x="994870" y="2951253"/>
            <a:ext cx="16373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FACS sorting</a:t>
            </a:r>
          </a:p>
        </p:txBody>
      </p:sp>
    </p:spTree>
    <p:extLst>
      <p:ext uri="{BB962C8B-B14F-4D97-AF65-F5344CB8AC3E}">
        <p14:creationId xmlns:p14="http://schemas.microsoft.com/office/powerpoint/2010/main" val="9210189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4E568D-7AED-41F2-8010-72A51D69669C}"/>
              </a:ext>
            </a:extLst>
          </p:cNvPr>
          <p:cNvSpPr txBox="1"/>
          <p:nvPr/>
        </p:nvSpPr>
        <p:spPr>
          <a:xfrm>
            <a:off x="495300" y="514408"/>
            <a:ext cx="5867400" cy="79346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Regulatory T cell-mediated suppression and pro- inflammatory cytokines production. </a:t>
            </a:r>
          </a:p>
          <a:p>
            <a:pPr algn="just">
              <a:lnSpc>
                <a:spcPct val="200000"/>
              </a:lnSpc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Total Treg and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/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reg were isolated from fresh PBMC of healthy donors for functional assessment.</a:t>
            </a: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R="215900" lvl="0" algn="just">
              <a:lnSpc>
                <a:spcPct val="200000"/>
              </a:lnSpc>
              <a:spcBef>
                <a:spcPts val="795"/>
              </a:spcBef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a) Representative dot-plots showing strategy for enrichment of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/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Treg. (</a:t>
            </a:r>
            <a:r>
              <a:rPr lang="en-US" sz="1200" dirty="0" err="1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) Purity checking post negative enrichment of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 cells based on MACS sorting; (ii) </a:t>
            </a: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Gating strategy for enrichment of CD49f</a:t>
            </a:r>
            <a:r>
              <a:rPr lang="en-AU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nd CD49f</a:t>
            </a:r>
            <a:r>
              <a:rPr lang="en-AU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T reg from CD25</a:t>
            </a:r>
            <a:r>
              <a:rPr lang="en-AU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AU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 cells based on FACS sorting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aph showing the fraction of proliferative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cultured in the presence or absence of total Treg at various Treg: conv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 ratios. Data represents one donor analyzed and includes 3 technical replicates. *p&lt;0.05, **p&lt;0.01 and ***p&lt;0.001. Non-parametric paired t-test. Bars represent standard error of mean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 Representative FACS dot-plot showing IL-17A expression on total Treg following overnight activation in the presence of CD3/CD28 Dynabeads and recombinant IL-2 during five days of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vitro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ulture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 Fraction of IFNγ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in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g. Data was obtained from four healthy donors analyzed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e) Representative FACS dot-plot showing IL-17A and IFNγ co-expression on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g.</a:t>
            </a:r>
          </a:p>
        </p:txBody>
      </p:sp>
    </p:spTree>
    <p:extLst>
      <p:ext uri="{BB962C8B-B14F-4D97-AF65-F5344CB8AC3E}">
        <p14:creationId xmlns:p14="http://schemas.microsoft.com/office/powerpoint/2010/main" val="41857826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oup 93">
            <a:extLst>
              <a:ext uri="{FF2B5EF4-FFF2-40B4-BE49-F238E27FC236}">
                <a16:creationId xmlns:a16="http://schemas.microsoft.com/office/drawing/2014/main" id="{6A880ED4-B860-4B21-8FE9-EF90A32CDD19}"/>
              </a:ext>
            </a:extLst>
          </p:cNvPr>
          <p:cNvGrpSpPr/>
          <p:nvPr/>
        </p:nvGrpSpPr>
        <p:grpSpPr>
          <a:xfrm>
            <a:off x="207086" y="309606"/>
            <a:ext cx="6001338" cy="6486701"/>
            <a:chOff x="207086" y="309606"/>
            <a:chExt cx="6001338" cy="6486701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7BC50FA-096F-49EE-A2CF-D99D1D417D77}"/>
                </a:ext>
              </a:extLst>
            </p:cNvPr>
            <p:cNvSpPr txBox="1"/>
            <p:nvPr/>
          </p:nvSpPr>
          <p:spPr>
            <a:xfrm>
              <a:off x="207086" y="309606"/>
              <a:ext cx="33698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3</a:t>
              </a: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096DA735-11DB-4582-A1E6-8E640CBF651D}"/>
                </a:ext>
              </a:extLst>
            </p:cNvPr>
            <p:cNvGrpSpPr/>
            <p:nvPr/>
          </p:nvGrpSpPr>
          <p:grpSpPr>
            <a:xfrm>
              <a:off x="556924" y="1246959"/>
              <a:ext cx="5651500" cy="5549348"/>
              <a:chOff x="556924" y="1246959"/>
              <a:chExt cx="5651500" cy="5549348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2"/>
              <a:srcRect t="10784" r="51171" b="10994"/>
              <a:stretch/>
            </p:blipFill>
            <p:spPr>
              <a:xfrm>
                <a:off x="997109" y="1504884"/>
                <a:ext cx="2388554" cy="2576048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1F4191F-D0BA-42DE-BBFD-3E848FB43E84}"/>
                  </a:ext>
                </a:extLst>
              </p:cNvPr>
              <p:cNvSpPr txBox="1"/>
              <p:nvPr/>
            </p:nvSpPr>
            <p:spPr>
              <a:xfrm>
                <a:off x="556924" y="1262198"/>
                <a:ext cx="67137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A1E46BB4-755C-40C1-8859-2D140EF2FC38}"/>
                  </a:ext>
                </a:extLst>
              </p:cNvPr>
              <p:cNvSpPr txBox="1"/>
              <p:nvPr/>
            </p:nvSpPr>
            <p:spPr>
              <a:xfrm>
                <a:off x="3022366" y="1246959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B8C267C-C83E-4498-8691-470B58EE17F0}"/>
                  </a:ext>
                </a:extLst>
              </p:cNvPr>
              <p:cNvSpPr txBox="1"/>
              <p:nvPr/>
            </p:nvSpPr>
            <p:spPr>
              <a:xfrm>
                <a:off x="1094258" y="3211263"/>
                <a:ext cx="2202980" cy="256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 genes: 17,936</a:t>
                </a: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3227955-67FD-4CD7-A903-3BF9378A2F12}"/>
                  </a:ext>
                </a:extLst>
              </p:cNvPr>
              <p:cNvSpPr/>
              <p:nvPr/>
            </p:nvSpPr>
            <p:spPr>
              <a:xfrm>
                <a:off x="1780997" y="1834330"/>
                <a:ext cx="1211024" cy="1193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A597D5C-FE9E-4383-953E-534A856F6938}"/>
                  </a:ext>
                </a:extLst>
              </p:cNvPr>
              <p:cNvSpPr txBox="1"/>
              <p:nvPr/>
            </p:nvSpPr>
            <p:spPr>
              <a:xfrm>
                <a:off x="988416" y="1612952"/>
                <a:ext cx="2313745" cy="256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E genes: 668 (2.68%)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907F8B35-2AE9-4A9C-ABEC-C1FE921634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duotone>
                  <a:prstClr val="black"/>
                  <a:schemeClr val="accent6">
                    <a:tint val="45000"/>
                    <a:satMod val="400000"/>
                  </a:schemeClr>
                </a:duotone>
              </a:blip>
              <a:stretch>
                <a:fillRect/>
              </a:stretch>
            </p:blipFill>
            <p:spPr>
              <a:xfrm>
                <a:off x="3243437" y="1246959"/>
                <a:ext cx="2617454" cy="3352338"/>
              </a:xfrm>
              <a:prstGeom prst="rect">
                <a:avLst/>
              </a:prstGeom>
            </p:spPr>
          </p:pic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0D49179D-1FEF-427C-84FF-0C2DE20262D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21239311"/>
                  </p:ext>
                </p:extLst>
              </p:nvPr>
            </p:nvGraphicFramePr>
            <p:xfrm>
              <a:off x="556924" y="4338857"/>
              <a:ext cx="5651500" cy="24574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5651642" imgH="2457818" progId="Prism8.Document">
                      <p:embed/>
                    </p:oleObj>
                  </mc:Choice>
                  <mc:Fallback>
                    <p:oleObj name="Prism 8" r:id="rId4" imgW="5651642" imgH="2457818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56924" y="4338857"/>
                            <a:ext cx="5651500" cy="24574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B6D4BAC-7B99-4E87-81E7-EF21E5F0505D}"/>
                  </a:ext>
                </a:extLst>
              </p:cNvPr>
              <p:cNvSpPr txBox="1"/>
              <p:nvPr/>
            </p:nvSpPr>
            <p:spPr>
              <a:xfrm>
                <a:off x="572164" y="4325438"/>
                <a:ext cx="65613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2D2007F1-05FE-469B-AB06-52CCFE17C9C4}"/>
                  </a:ext>
                </a:extLst>
              </p:cNvPr>
              <p:cNvSpPr txBox="1"/>
              <p:nvPr/>
            </p:nvSpPr>
            <p:spPr>
              <a:xfrm rot="18859384">
                <a:off x="4134215" y="3456008"/>
                <a:ext cx="792000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9f</a:t>
                </a:r>
                <a:r>
                  <a:rPr lang="en-AU" sz="11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85A9092D-C82E-4C62-A9E8-8F4A69EC43AA}"/>
                  </a:ext>
                </a:extLst>
              </p:cNvPr>
              <p:cNvSpPr txBox="1"/>
              <p:nvPr/>
            </p:nvSpPr>
            <p:spPr>
              <a:xfrm rot="18859384">
                <a:off x="4673965" y="3456008"/>
                <a:ext cx="792000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AU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9f</a:t>
                </a:r>
                <a:r>
                  <a:rPr lang="en-AU" sz="11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5998541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4E568D-7AED-41F2-8010-72A51D69669C}"/>
              </a:ext>
            </a:extLst>
          </p:cNvPr>
          <p:cNvSpPr txBox="1"/>
          <p:nvPr/>
        </p:nvSpPr>
        <p:spPr>
          <a:xfrm>
            <a:off x="495300" y="459817"/>
            <a:ext cx="5867400" cy="5019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. Genes modulated in CD49f negative versus CD49f</a:t>
            </a:r>
            <a:r>
              <a:rPr lang="en-US" sz="12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gulatory T cells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NA-Seq analysis of Treg subsets from PBMC of healthy donors. </a:t>
            </a: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R="216535" lvl="0" algn="just">
              <a:lnSpc>
                <a:spcPct val="208000"/>
              </a:lnSpc>
              <a:spcBef>
                <a:spcPts val="795"/>
              </a:spcBef>
              <a:buSzPts val="1200"/>
              <a:tabLst>
                <a:tab pos="598170" algn="l"/>
              </a:tabLs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Pie chart showing total genes analyzed and DE genes between CD49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CD49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reg using RNA-Seq data across multiple</a:t>
            </a:r>
            <a:r>
              <a:rPr lang="en-US" sz="1200" spc="-185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onors.</a:t>
            </a: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R="215900" lvl="0" algn="just">
              <a:lnSpc>
                <a:spcPct val="208000"/>
              </a:lnSpc>
              <a:spcBef>
                <a:spcPts val="785"/>
              </a:spcBef>
              <a:buSzPts val="1200"/>
              <a:tabLst>
                <a:tab pos="621030" algn="l"/>
              </a:tabLs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b) Number of genes over-expressed and under-expressed from total DE genes between CD49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CD49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reg using RNA-Seq data across multiple</a:t>
            </a:r>
            <a:r>
              <a:rPr lang="en-US" sz="1200" spc="-165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onors.</a:t>
            </a:r>
          </a:p>
          <a:p>
            <a:pPr marR="215900" algn="just">
              <a:lnSpc>
                <a:spcPct val="208000"/>
              </a:lnSpc>
              <a:spcBef>
                <a:spcPts val="785"/>
              </a:spcBef>
              <a:buSzPts val="1200"/>
              <a:tabLst>
                <a:tab pos="621030" algn="l"/>
              </a:tabLs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c) Graphs showing DE genes in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versus CD49f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reg (n = 4). Genes were grouped as markers associated with Th1 signature. *P &lt; 0.05, **P &lt; 0.01. Non-parametric t-test.</a:t>
            </a: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R="215900" lvl="0" algn="just">
              <a:lnSpc>
                <a:spcPct val="208000"/>
              </a:lnSpc>
              <a:spcBef>
                <a:spcPts val="785"/>
              </a:spcBef>
              <a:buSzPts val="1200"/>
              <a:tabLst>
                <a:tab pos="621030" algn="l"/>
              </a:tabLst>
            </a:pP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0052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353FDFE-7928-4C94-9E88-A3092239E9FC}"/>
              </a:ext>
            </a:extLst>
          </p:cNvPr>
          <p:cNvGrpSpPr/>
          <p:nvPr/>
        </p:nvGrpSpPr>
        <p:grpSpPr>
          <a:xfrm>
            <a:off x="207086" y="309606"/>
            <a:ext cx="5969020" cy="9567819"/>
            <a:chOff x="207086" y="309606"/>
            <a:chExt cx="5969020" cy="9567819"/>
          </a:xfrm>
        </p:grpSpPr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8C111577-1977-494E-ABFC-F95CCCA1DE5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59245279"/>
                </p:ext>
              </p:extLst>
            </p:nvPr>
          </p:nvGraphicFramePr>
          <p:xfrm>
            <a:off x="887833" y="870288"/>
            <a:ext cx="5288273" cy="42758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7288354" imgH="5891132" progId="Prism8.Document">
                    <p:embed/>
                  </p:oleObj>
                </mc:Choice>
                <mc:Fallback>
                  <p:oleObj name="Prism 8" r:id="rId2" imgW="7288354" imgH="5891132" progId="Prism8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E41DF6E6-EFA8-4171-A35E-33FAC1C4FD1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87833" y="870288"/>
                          <a:ext cx="5288273" cy="427584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7C72C23-3AF5-4CBB-908E-E2F2F44C0C6E}"/>
                </a:ext>
              </a:extLst>
            </p:cNvPr>
            <p:cNvSpPr txBox="1"/>
            <p:nvPr/>
          </p:nvSpPr>
          <p:spPr>
            <a:xfrm>
              <a:off x="207086" y="309606"/>
              <a:ext cx="33698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4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81CB9D9-06DA-4189-AE3C-A2CEBEBD54CE}"/>
                </a:ext>
              </a:extLst>
            </p:cNvPr>
            <p:cNvSpPr txBox="1"/>
            <p:nvPr/>
          </p:nvSpPr>
          <p:spPr>
            <a:xfrm>
              <a:off x="370114" y="1001699"/>
              <a:ext cx="4850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8D0682E-D7D5-470A-9590-3487220DD88F}"/>
                </a:ext>
              </a:extLst>
            </p:cNvPr>
            <p:cNvSpPr txBox="1"/>
            <p:nvPr/>
          </p:nvSpPr>
          <p:spPr>
            <a:xfrm>
              <a:off x="408215" y="5146135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A90A23D3-2E73-4C48-8E80-3E89D58960A0}"/>
                </a:ext>
              </a:extLst>
            </p:cNvPr>
            <p:cNvGrpSpPr/>
            <p:nvPr/>
          </p:nvGrpSpPr>
          <p:grpSpPr>
            <a:xfrm>
              <a:off x="1095375" y="5108875"/>
              <a:ext cx="4614863" cy="4768550"/>
              <a:chOff x="1125741" y="920682"/>
              <a:chExt cx="4614863" cy="4768550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25BA10D5-431E-4CED-8031-BEA6F9AE3C1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40886698"/>
                  </p:ext>
                </p:extLst>
              </p:nvPr>
            </p:nvGraphicFramePr>
            <p:xfrm>
              <a:off x="1125741" y="1052145"/>
              <a:ext cx="4614863" cy="46370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6335915" imgH="6369521" progId="Prism8.Document">
                      <p:embed/>
                    </p:oleObj>
                  </mc:Choice>
                  <mc:Fallback>
                    <p:oleObj name="Prism 8" r:id="rId4" imgW="6335915" imgH="6369521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1125741" y="1052145"/>
                            <a:ext cx="4614863" cy="46370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F28F69BD-3A42-4646-AE0C-2164D9F79494}"/>
                  </a:ext>
                </a:extLst>
              </p:cNvPr>
              <p:cNvSpPr txBox="1"/>
              <p:nvPr/>
            </p:nvSpPr>
            <p:spPr>
              <a:xfrm rot="16200000">
                <a:off x="964712" y="1610840"/>
                <a:ext cx="7104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5 MFI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A76904F-D5AF-4809-90BB-0CBC17362EE2}"/>
                  </a:ext>
                </a:extLst>
              </p:cNvPr>
              <p:cNvSpPr txBox="1"/>
              <p:nvPr/>
            </p:nvSpPr>
            <p:spPr>
              <a:xfrm rot="16200000">
                <a:off x="945352" y="2868140"/>
                <a:ext cx="7745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27 MFI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F31EA6B-DFF8-4B45-BFAB-EB8A7E29C2A4}"/>
                  </a:ext>
                </a:extLst>
              </p:cNvPr>
              <p:cNvSpPr txBox="1"/>
              <p:nvPr/>
            </p:nvSpPr>
            <p:spPr>
              <a:xfrm rot="16200000">
                <a:off x="942146" y="4290540"/>
                <a:ext cx="7809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49f  MFI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EF66724-7FF8-44E7-A8A3-2DE2ADDFAD3D}"/>
                  </a:ext>
                </a:extLst>
              </p:cNvPr>
              <p:cNvSpPr txBox="1"/>
              <p:nvPr/>
            </p:nvSpPr>
            <p:spPr>
              <a:xfrm>
                <a:off x="1786193" y="920682"/>
                <a:ext cx="9813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ffector </a:t>
                </a:r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A88A62B-8093-414B-86EA-39DE99D9046F}"/>
                  </a:ext>
                </a:extLst>
              </p:cNvPr>
              <p:cNvSpPr txBox="1"/>
              <p:nvPr/>
            </p:nvSpPr>
            <p:spPr>
              <a:xfrm>
                <a:off x="3198901" y="928704"/>
                <a:ext cx="96693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sting </a:t>
                </a:r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1075347-BDE7-4029-AEB4-A28B5E229EFE}"/>
                  </a:ext>
                </a:extLst>
              </p:cNvPr>
              <p:cNvSpPr txBox="1"/>
              <p:nvPr/>
            </p:nvSpPr>
            <p:spPr>
              <a:xfrm>
                <a:off x="4525948" y="920684"/>
                <a:ext cx="1213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 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n </a:t>
                </a:r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eg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6808460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4E568D-7AED-41F2-8010-72A51D69669C}"/>
              </a:ext>
            </a:extLst>
          </p:cNvPr>
          <p:cNvSpPr txBox="1"/>
          <p:nvPr/>
        </p:nvSpPr>
        <p:spPr>
          <a:xfrm>
            <a:off x="495300" y="514408"/>
            <a:ext cx="5867400" cy="5144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. Modulation of immune markers in subsets of regulatory T cells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low cytometric analysis of Treg subsets from PBMC of healthy donors. </a:t>
            </a:r>
            <a:endParaRPr lang="en-AU" sz="1200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AU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(a)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s were classified as effector Treg (CD2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127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oxP3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igh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45R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, resting Treg (CD2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127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oxP3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ow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45R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 and FoxP3+ non Treg cells (CD25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127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oxP3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ow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D45R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). Graphs showing CD4, CD25, CD39, CTLA4, CCR6 and CD25 MFI distribution across the different subsets. Each symbol represents an individual donor analyzed (n = 10). n.s. = non-significant, P*&lt;0.05, P**&lt;0.01, P***&lt;0.001, P****&lt;0.0005. Non-parametric one- way </a:t>
            </a:r>
            <a:r>
              <a:rPr lang="en-US" sz="1200" spc="-2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NOVA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test with Bonferroni</a:t>
            </a:r>
            <a:r>
              <a:rPr lang="en-US" sz="1200" spc="-155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orrection.</a:t>
            </a:r>
            <a:endParaRPr lang="en-AU" sz="1200" dirty="0"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) Graphs representing the correlation between CD49f expression and CD25, CD127 and CD49f MFI across the different Treg subsets. Each symbol represents an individual donor analyzed (n = 10). *P &lt; 0.05, **P &lt; 0.01, ****P &lt;0.0005. Non-parametric one-way ANOVA test with Bonferroni correction.</a:t>
            </a:r>
            <a:endParaRPr lang="en-AU" sz="12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6502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951</TotalTime>
  <Words>1276</Words>
  <Application>Microsoft Office PowerPoint</Application>
  <PresentationFormat>A4 Paper (210x297 mm)</PresentationFormat>
  <Paragraphs>102</Paragraphs>
  <Slides>11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QIMR Berghof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lin Lepletier</dc:creator>
  <cp:lastModifiedBy>Ailin Lepletier</cp:lastModifiedBy>
  <cp:revision>203</cp:revision>
  <cp:lastPrinted>2019-10-15T07:25:11Z</cp:lastPrinted>
  <dcterms:created xsi:type="dcterms:W3CDTF">2019-10-15T06:52:56Z</dcterms:created>
  <dcterms:modified xsi:type="dcterms:W3CDTF">2021-08-13T08:53:43Z</dcterms:modified>
</cp:coreProperties>
</file>